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tags/tag1.xml" ContentType="application/vnd.openxmlformats-officedocument.presentationml.tags+xml"/>
  <Override PartName="/ppt/notesSlides/notesSlide4.xml" ContentType="application/vnd.openxmlformats-officedocument.presentationml.notesSlide+xml"/>
  <Override PartName="/ppt/tags/tag2.xml" ContentType="application/vnd.openxmlformats-officedocument.presentationml.tags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tags/tag3.xml" ContentType="application/vnd.openxmlformats-officedocument.presentationml.tags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4"/>
  </p:sldMasterIdLst>
  <p:notesMasterIdLst>
    <p:notesMasterId r:id="rId14"/>
  </p:notesMasterIdLst>
  <p:sldIdLst>
    <p:sldId id="256" r:id="rId5"/>
    <p:sldId id="323" r:id="rId6"/>
    <p:sldId id="327" r:id="rId7"/>
    <p:sldId id="287" r:id="rId8"/>
    <p:sldId id="288" r:id="rId9"/>
    <p:sldId id="328" r:id="rId10"/>
    <p:sldId id="289" r:id="rId11"/>
    <p:sldId id="329" r:id="rId12"/>
    <p:sldId id="298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garet Maria Cocks" initials="MMC" lastIdx="16" clrIdx="0">
    <p:extLst>
      <p:ext uri="{19B8F6BF-5375-455C-9EA6-DF929625EA0E}">
        <p15:presenceInfo xmlns:p15="http://schemas.microsoft.com/office/powerpoint/2012/main" userId="Margaret Maria Cocks" providerId="None"/>
      </p:ext>
    </p:extLst>
  </p:cmAuthor>
  <p:cmAuthor id="2" name="Nathanael Coombs Jensen" initials="NCJ" lastIdx="34" clrIdx="1">
    <p:extLst>
      <p:ext uri="{19B8F6BF-5375-455C-9EA6-DF929625EA0E}">
        <p15:presenceInfo xmlns:p15="http://schemas.microsoft.com/office/powerpoint/2012/main" userId="S::u1270197@umail.utah.edu::fe7ba4c0-5eb4-42d2-b0ff-afc6d805d683" providerId="AD"/>
      </p:ext>
    </p:extLst>
  </p:cmAuthor>
  <p:cmAuthor id="3" name="Sarah Cipriano" initials="SC" lastIdx="3" clrIdx="2">
    <p:extLst>
      <p:ext uri="{19B8F6BF-5375-455C-9EA6-DF929625EA0E}">
        <p15:presenceInfo xmlns:p15="http://schemas.microsoft.com/office/powerpoint/2012/main" userId="S-1-5-21-1599696121-1964574698-334091239-242256" providerId="AD"/>
      </p:ext>
    </p:extLst>
  </p:cmAuthor>
  <p:cmAuthor id="4" name="Stoff, Benjamin K." initials="SBK" lastIdx="3" clrIdx="3">
    <p:extLst>
      <p:ext uri="{19B8F6BF-5375-455C-9EA6-DF929625EA0E}">
        <p15:presenceInfo xmlns:p15="http://schemas.microsoft.com/office/powerpoint/2012/main" userId="S::BSTOFF@emory.edu::1e2c89ab-c7e0-43cb-8b4e-198bf9fde1d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173"/>
    <p:restoredTop sz="63275" autoAdjust="0"/>
  </p:normalViewPr>
  <p:slideViewPr>
    <p:cSldViewPr>
      <p:cViewPr varScale="1">
        <p:scale>
          <a:sx n="69" d="100"/>
          <a:sy n="69" d="100"/>
        </p:scale>
        <p:origin x="2472" y="6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79" d="100"/>
          <a:sy n="79" d="100"/>
        </p:scale>
        <p:origin x="3440" y="20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commentAuthors" Target="commentAuthors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0068B2-954D-459C-9B92-B731DEA101A0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AB8820-870D-4223-B07D-D25F8C4BC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665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Introduce yourself and any cofacilitators</a:t>
            </a:r>
          </a:p>
          <a:p>
            <a:r>
              <a:rPr lang="en-US" i="1" dirty="0"/>
              <a:t>This primer helps to introduce the audience to key principles of biomedical ethic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AB8820-870D-4223-B07D-D25F8C4BC2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6821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Wait for a response from the audience before moving on to the next few slides</a:t>
            </a:r>
          </a:p>
          <a:p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AB8820-870D-4223-B07D-D25F8C4BC2F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5319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A possible example of a conflict that may have competing values:</a:t>
            </a:r>
          </a:p>
          <a:p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i="1" dirty="0">
                <a:latin typeface="Calibri" panose="020F0502020204030204" pitchFamily="34" charset="0"/>
                <a:cs typeface="Calibri" panose="020F0502020204030204" pitchFamily="34" charset="0"/>
              </a:rPr>
              <a:t>Example: Seeing a patient in follow-up and noticing a misdiagnosis by a colleague – not harmful, not consequential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i="1" dirty="0">
                <a:latin typeface="Calibri" panose="020F0502020204030204" pitchFamily="34" charset="0"/>
                <a:cs typeface="Calibri" panose="020F0502020204030204" pitchFamily="34" charset="0"/>
              </a:rPr>
              <a:t>Do nothing further (values – collegiality with colleague, well-being of patient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i="1" dirty="0">
                <a:latin typeface="Calibri" panose="020F0502020204030204" pitchFamily="34" charset="0"/>
                <a:cs typeface="Calibri" panose="020F0502020204030204" pitchFamily="34" charset="0"/>
              </a:rPr>
              <a:t>Inform colleague of error (values – duty to report error, respect of provider-patient relationship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i="1" dirty="0">
                <a:latin typeface="Calibri" panose="020F0502020204030204" pitchFamily="34" charset="0"/>
                <a:cs typeface="Calibri" panose="020F0502020204030204" pitchFamily="34" charset="0"/>
              </a:rPr>
              <a:t>Inform patient of error (value – autonomy of patient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08CFB5-0B3A-4B5D-8C68-9530D9309E5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9969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Regarding “No clear right answer”, emphasize that there </a:t>
            </a:r>
            <a:r>
              <a:rPr lang="en-US" sz="1200" i="1" dirty="0">
                <a:latin typeface="Calibri" panose="020F0502020204030204" pitchFamily="34" charset="0"/>
                <a:cs typeface="Calibri" panose="020F0502020204030204" pitchFamily="34" charset="0"/>
              </a:rPr>
              <a:t>may be a range of acceptable courses of action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i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i="1" dirty="0">
                <a:latin typeface="Calibri" panose="020F0502020204030204" pitchFamily="34" charset="0"/>
                <a:cs typeface="Calibri" panose="020F0502020204030204" pitchFamily="34" charset="0"/>
              </a:rPr>
              <a:t>As far as “justification” for choosing an alternative, emphasize that these decisions are based on moral theory (not purely medical, legal, compliance, etc.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08CFB5-0B3A-4B5D-8C68-9530D9309E5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373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These four principles of biomedical ethics come from the work of two philosophers, Dr. Thomas Beauchamp and Dr. James Childress.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ir book Principles of Biomedical Ethics was first published in 1985, where it quickly became utilized in healthcare and academia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These principles are often in tension with one another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6B9C62-8D35-4E40-A0E2-D016B043A0E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80576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In addition to those four principles, we draw upon other principl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AB8820-870D-4223-B07D-D25F8C4BC2F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64607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Given that it’s hard to operationalize working through ethical principles, ethicists have come up with other ways of making decisions. For example, the quadrant model, which is a checklist that can be used when navigating a tough cas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20438E-C18E-42B4-A965-C827756AA75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0835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The American Society of Bioethics and Humanities identified these as the more classic issues in bioethic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AB8820-870D-4223-B07D-D25F8C4BC2F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86798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AB8820-870D-4223-B07D-D25F8C4BC2F2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86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HD-ShadowLong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242851"/>
            <a:ext cx="6726063" cy="275942"/>
          </a:xfrm>
          <a:prstGeom prst="rect">
            <a:avLst/>
          </a:prstGeom>
        </p:spPr>
      </p:pic>
      <p:pic>
        <p:nvPicPr>
          <p:cNvPr id="8" name="Picture 7" descr="HD-ShadowShort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3787" y="4243845"/>
            <a:ext cx="2307831" cy="27694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 bwMode="ltGray">
          <a:xfrm>
            <a:off x="0" y="2590078"/>
            <a:ext cx="6726064" cy="1660332"/>
          </a:xfrm>
          <a:prstGeom prst="rect">
            <a:avLst/>
          </a:prstGeom>
          <a:solidFill>
            <a:schemeClr val="bg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" name="Rectangle 9"/>
          <p:cNvSpPr/>
          <p:nvPr/>
        </p:nvSpPr>
        <p:spPr>
          <a:xfrm>
            <a:off x="6833787" y="2590078"/>
            <a:ext cx="2307832" cy="166033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0242" y="2733709"/>
            <a:ext cx="6069268" cy="1373070"/>
          </a:xfrm>
        </p:spPr>
        <p:txBody>
          <a:bodyPr anchor="b">
            <a:noAutofit/>
          </a:bodyPr>
          <a:lstStyle>
            <a:lvl1pPr algn="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0241" y="4394040"/>
            <a:ext cx="6108101" cy="1117687"/>
          </a:xfrm>
        </p:spPr>
        <p:txBody>
          <a:bodyPr>
            <a:normAutofit/>
          </a:bodyPr>
          <a:lstStyle>
            <a:lvl1pPr marL="0" indent="0" algn="r">
              <a:buNone/>
              <a:defRPr sz="20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55655" y="5936188"/>
            <a:ext cx="2057400" cy="365125"/>
          </a:xfrm>
        </p:spPr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33401" y="5936189"/>
            <a:ext cx="4021666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010399" y="2750337"/>
            <a:ext cx="1370293" cy="1356442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02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0" y="4572000"/>
            <a:ext cx="9161969" cy="1677035"/>
            <a:chOff x="0" y="2895600"/>
            <a:chExt cx="9161969" cy="1677035"/>
          </a:xfrm>
        </p:grpSpPr>
        <p:pic>
          <p:nvPicPr>
            <p:cNvPr id="24" name="Picture 23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5" name="Picture 24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6" name="Rectangle 25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Rectangle 26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3" y="4711617"/>
            <a:ext cx="6894770" cy="544482"/>
          </a:xfrm>
        </p:spPr>
        <p:txBody>
          <a:bodyPr anchor="b">
            <a:normAutofit/>
          </a:bodyPr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1639" y="609598"/>
            <a:ext cx="6896534" cy="3589575"/>
          </a:xfrm>
          <a:noFill/>
          <a:ln>
            <a:noFill/>
          </a:ln>
          <a:effectLst>
            <a:outerShdw blurRad="76200" dist="63500" dir="5040000" algn="tl" rotWithShape="0">
              <a:srgbClr val="000000">
                <a:alpha val="41000"/>
              </a:srgbClr>
            </a:outerShdw>
          </a:effectLst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401" y="5256098"/>
            <a:ext cx="6894772" cy="54781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856438" y="4711310"/>
            <a:ext cx="1149836" cy="1090789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919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0" y="4572000"/>
            <a:ext cx="9161969" cy="1677035"/>
            <a:chOff x="0" y="2895600"/>
            <a:chExt cx="9161969" cy="1677035"/>
          </a:xfrm>
        </p:grpSpPr>
        <p:pic>
          <p:nvPicPr>
            <p:cNvPr id="22" name="Picture 21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3" name="Picture 22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4" name="Rectangle 23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4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4255" y="609597"/>
            <a:ext cx="6896534" cy="3592750"/>
          </a:xfrm>
        </p:spPr>
        <p:txBody>
          <a:bodyPr anchor="ctr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1638" y="4710340"/>
            <a:ext cx="6889151" cy="1101764"/>
          </a:xfrm>
        </p:spPr>
        <p:txBody>
          <a:bodyPr anchor="ctr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856438" y="4711616"/>
            <a:ext cx="1149836" cy="1090789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2533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0" y="4572000"/>
            <a:ext cx="9161969" cy="1677035"/>
            <a:chOff x="0" y="2895600"/>
            <a:chExt cx="9161969" cy="1677035"/>
          </a:xfrm>
        </p:grpSpPr>
        <p:pic>
          <p:nvPicPr>
            <p:cNvPr id="30" name="Picture 29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31" name="Picture 30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32" name="Rectangle 31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3" name="Rectangle 32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7921" y="616983"/>
            <a:ext cx="6425147" cy="3036061"/>
          </a:xfrm>
        </p:spPr>
        <p:txBody>
          <a:bodyPr anchor="ctr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989438" y="3660763"/>
            <a:ext cx="5987731" cy="54896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1638" y="4710340"/>
            <a:ext cx="6903919" cy="1101764"/>
          </a:xfrm>
        </p:spPr>
        <p:txBody>
          <a:bodyPr anchor="ctr">
            <a:normAutofit/>
          </a:bodyPr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856438" y="4709926"/>
            <a:ext cx="1149836" cy="1090789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270932" y="748116"/>
            <a:ext cx="5334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72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967191" y="2998573"/>
            <a:ext cx="457200" cy="5847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72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10179213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0" y="4572000"/>
            <a:ext cx="9161969" cy="1677035"/>
            <a:chOff x="0" y="2895600"/>
            <a:chExt cx="9161969" cy="1677035"/>
          </a:xfrm>
        </p:grpSpPr>
        <p:pic>
          <p:nvPicPr>
            <p:cNvPr id="23" name="Picture 22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4" name="Picture 23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5" name="Rectangle 24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Rectangle 25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8" y="4710340"/>
            <a:ext cx="6896534" cy="58981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1639" y="5300150"/>
            <a:ext cx="6896534" cy="511954"/>
          </a:xfrm>
        </p:spPr>
        <p:txBody>
          <a:bodyPr anchor="t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856438" y="4709926"/>
            <a:ext cx="1149836" cy="1090789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5443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24" name="Picture 23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5" name="Picture 24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6" name="Rectangle 25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Rectangle 26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531639" y="753228"/>
            <a:ext cx="6896534" cy="108093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532629" y="2329489"/>
            <a:ext cx="219456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539777" y="3015290"/>
            <a:ext cx="2194560" cy="291351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878413" y="2336873"/>
            <a:ext cx="219456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2879710" y="3007906"/>
            <a:ext cx="2194560" cy="291351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5226136" y="2336873"/>
            <a:ext cx="219456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5233520" y="3007905"/>
            <a:ext cx="2194560" cy="291351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03064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35" name="Picture 34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36" name="Picture 35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37" name="Rectangle 36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8" name="Rectangle 37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531639" y="753228"/>
            <a:ext cx="6896534" cy="108093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532391" y="4297503"/>
            <a:ext cx="21922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532391" y="2336873"/>
            <a:ext cx="2192257" cy="1524000"/>
          </a:xfrm>
          <a:prstGeom prst="roundRect">
            <a:avLst>
              <a:gd name="adj" fmla="val 0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532391" y="4873765"/>
            <a:ext cx="2192257" cy="106242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870497" y="4297503"/>
            <a:ext cx="221507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2870497" y="2336873"/>
            <a:ext cx="2215070" cy="1524000"/>
          </a:xfrm>
          <a:prstGeom prst="roundRect">
            <a:avLst>
              <a:gd name="adj" fmla="val 0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2869483" y="4873764"/>
            <a:ext cx="2218004" cy="106242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5231028" y="4297503"/>
            <a:ext cx="219433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5231027" y="2336873"/>
            <a:ext cx="2194333" cy="1524000"/>
          </a:xfrm>
          <a:prstGeom prst="roundRect">
            <a:avLst>
              <a:gd name="adj" fmla="val 0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5230934" y="4873762"/>
            <a:ext cx="2197239" cy="106242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13017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17" name="Picture 16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18" name="Picture 17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19" name="Rectangle 18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Rectangle 19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9" y="753228"/>
            <a:ext cx="6896534" cy="1080938"/>
          </a:xfrm>
        </p:spPr>
        <p:txBody>
          <a:bodyPr/>
          <a:lstStyle>
            <a:lvl1pPr algn="r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7387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 rot="5400000">
            <a:off x="4575305" y="2747178"/>
            <a:ext cx="6862555" cy="1368199"/>
            <a:chOff x="2281445" y="609600"/>
            <a:chExt cx="6862555" cy="1368199"/>
          </a:xfrm>
        </p:grpSpPr>
        <p:sp>
          <p:nvSpPr>
            <p:cNvPr id="12" name="Rectangle 11"/>
            <p:cNvSpPr/>
            <p:nvPr/>
          </p:nvSpPr>
          <p:spPr bwMode="ltGray">
            <a:xfrm>
              <a:off x="2281445" y="609601"/>
              <a:ext cx="5285695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Rectangle 12"/>
            <p:cNvSpPr/>
            <p:nvPr/>
          </p:nvSpPr>
          <p:spPr>
            <a:xfrm>
              <a:off x="7710769" y="609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64798" y="609597"/>
            <a:ext cx="1069602" cy="446193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0241" y="609598"/>
            <a:ext cx="6576359" cy="532658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029144" y="5936188"/>
            <a:ext cx="2057400" cy="365125"/>
          </a:xfrm>
        </p:spPr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10241" y="5936189"/>
            <a:ext cx="4518959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431152" y="5432500"/>
            <a:ext cx="1149636" cy="1273100"/>
          </a:xfrm>
        </p:spPr>
        <p:txBody>
          <a:bodyPr anchor="t"/>
          <a:lstStyle>
            <a:lvl1pPr algn="ctr">
              <a:defRPr/>
            </a:lvl1pPr>
          </a:lstStyle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470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28" name="Picture 27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9" name="Picture 28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30" name="Rectangle 29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1" name="Rectangle 30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0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0" y="2728432"/>
            <a:ext cx="9161969" cy="1677035"/>
            <a:chOff x="0" y="2895600"/>
            <a:chExt cx="9161969" cy="1677035"/>
          </a:xfrm>
        </p:grpSpPr>
        <p:pic>
          <p:nvPicPr>
            <p:cNvPr id="19" name="Picture 18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20" name="Picture 19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1" name="Rectangle 20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Rectangle 21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9" y="2869895"/>
            <a:ext cx="6889150" cy="1090788"/>
          </a:xfrm>
        </p:spPr>
        <p:txBody>
          <a:bodyPr anchor="ctr">
            <a:normAutofit/>
          </a:bodyPr>
          <a:lstStyle>
            <a:lvl1pPr algn="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1639" y="4232172"/>
            <a:ext cx="6889150" cy="1704017"/>
          </a:xfrm>
        </p:spPr>
        <p:txBody>
          <a:bodyPr>
            <a:normAutofit/>
          </a:bodyPr>
          <a:lstStyle>
            <a:lvl1pPr marL="0" indent="0" algn="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365810" y="5936188"/>
            <a:ext cx="2057400" cy="365125"/>
          </a:xfrm>
        </p:spPr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33400" y="5936189"/>
            <a:ext cx="4834673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856438" y="2869896"/>
            <a:ext cx="1149836" cy="1090789"/>
          </a:xfrm>
        </p:spPr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50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18" name="Picture 17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19" name="Picture 18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0" name="Rectangle 19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Rectangle 20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0" y="753228"/>
            <a:ext cx="6887390" cy="108093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3400" y="2336873"/>
            <a:ext cx="3357899" cy="35993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1128" y="2336873"/>
            <a:ext cx="3359661" cy="35993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82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29" name="Picture 28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30" name="Picture 29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31" name="Rectangle 30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2" name="Rectangle 31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9" y="753230"/>
            <a:ext cx="6896534" cy="108093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0988" y="2336874"/>
            <a:ext cx="3145080" cy="69313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1638" y="3030009"/>
            <a:ext cx="3367045" cy="2906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82646" y="2336873"/>
            <a:ext cx="3145527" cy="69207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61129" y="3030009"/>
            <a:ext cx="3367044" cy="2906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788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16" name="Picture 15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17" name="Picture 16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18" name="Rectangle 17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Rectangle 18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604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HD-ShadowShort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871"/>
          <a:stretch/>
        </p:blipFill>
        <p:spPr>
          <a:xfrm>
            <a:off x="7717217" y="1973262"/>
            <a:ext cx="1444752" cy="14427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7710769" y="609600"/>
            <a:ext cx="1433231" cy="13681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759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18" name="Picture 17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19" name="Picture 18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0" name="Rectangle 19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Rectangle 20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9" y="753227"/>
            <a:ext cx="6896534" cy="1080940"/>
          </a:xfrm>
        </p:spPr>
        <p:txBody>
          <a:bodyPr anchor="ctr">
            <a:normAutofit/>
          </a:bodyPr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4385" y="2336874"/>
            <a:ext cx="3913788" cy="35993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401" y="2336873"/>
            <a:ext cx="2796240" cy="3599317"/>
          </a:xfrm>
        </p:spPr>
        <p:txBody>
          <a:bodyPr anchor="ctr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233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0" y="609600"/>
            <a:ext cx="9161969" cy="1677035"/>
            <a:chOff x="0" y="2895600"/>
            <a:chExt cx="9161969" cy="1677035"/>
          </a:xfrm>
        </p:grpSpPr>
        <p:pic>
          <p:nvPicPr>
            <p:cNvPr id="18" name="Picture 17" descr="HD-ShadowLong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82" r="-217"/>
            <a:stretch/>
          </p:blipFill>
          <p:spPr>
            <a:xfrm>
              <a:off x="0" y="4251471"/>
              <a:ext cx="7644384" cy="321164"/>
            </a:xfrm>
            <a:prstGeom prst="rect">
              <a:avLst/>
            </a:prstGeom>
          </p:spPr>
        </p:pic>
        <p:pic>
          <p:nvPicPr>
            <p:cNvPr id="19" name="Picture 18" descr="HD-ShadowShort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1"/>
            <a:stretch/>
          </p:blipFill>
          <p:spPr>
            <a:xfrm>
              <a:off x="7717217" y="4259262"/>
              <a:ext cx="1444752" cy="144270"/>
            </a:xfrm>
            <a:prstGeom prst="rect">
              <a:avLst/>
            </a:prstGeom>
          </p:spPr>
        </p:pic>
        <p:sp>
          <p:nvSpPr>
            <p:cNvPr id="20" name="Rectangle 19"/>
            <p:cNvSpPr/>
            <p:nvPr/>
          </p:nvSpPr>
          <p:spPr bwMode="ltGray">
            <a:xfrm>
              <a:off x="0" y="2895600"/>
              <a:ext cx="7567140" cy="1368198"/>
            </a:xfrm>
            <a:prstGeom prst="rect">
              <a:avLst/>
            </a:prstGeom>
            <a:solidFill>
              <a:schemeClr val="bg1">
                <a:lumMod val="85000"/>
                <a:lumOff val="1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Rectangle 20"/>
            <p:cNvSpPr/>
            <p:nvPr/>
          </p:nvSpPr>
          <p:spPr>
            <a:xfrm>
              <a:off x="7710769" y="2895600"/>
              <a:ext cx="1433231" cy="136819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639" y="753228"/>
            <a:ext cx="6896534" cy="1080938"/>
          </a:xfrm>
        </p:spPr>
        <p:txBody>
          <a:bodyPr anchor="ctr">
            <a:normAutofit/>
          </a:bodyPr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10956" y="2336874"/>
            <a:ext cx="3917217" cy="3599312"/>
          </a:xfrm>
          <a:noFill/>
          <a:ln>
            <a:noFill/>
          </a:ln>
          <a:effectLst>
            <a:outerShdw blurRad="76200" dist="63500" dir="5040000" algn="tl" rotWithShape="0">
              <a:srgbClr val="000000">
                <a:alpha val="41000"/>
              </a:srgbClr>
            </a:outerShdw>
          </a:effectLst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1638" y="2336874"/>
            <a:ext cx="2798487" cy="3599315"/>
          </a:xfrm>
        </p:spPr>
        <p:txBody>
          <a:bodyPr anchor="ctr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596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James\Desktop\msft\Berlin\build Assets\hashOverlaySD-FullResolve.png"/>
          <p:cNvPicPr>
            <a:picLocks noChangeAspect="1" noChangeArrowheads="1"/>
          </p:cNvPicPr>
          <p:nvPr/>
        </p:nvPicPr>
        <p:blipFill>
          <a:blip r:embed="rId19">
            <a:alphaModFix am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"/>
            <a:ext cx="9144000" cy="6858000"/>
          </a:xfrm>
          <a:prstGeom prst="rect">
            <a:avLst/>
          </a:prstGeom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1639" y="753228"/>
            <a:ext cx="6896534" cy="10809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3400" y="2336873"/>
            <a:ext cx="6887389" cy="35993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67881" y="5936188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24923B-4BC3-41D4-9101-D9E03C5F8A92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3400" y="5936189"/>
            <a:ext cx="483467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48600" y="753228"/>
            <a:ext cx="1157674" cy="10907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7B4A7-CE35-43A9-825F-10ECBC759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37268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  <p:sldLayoutId id="2147483943" r:id="rId13"/>
    <p:sldLayoutId id="2147483944" r:id="rId14"/>
    <p:sldLayoutId id="2147483945" r:id="rId15"/>
    <p:sldLayoutId id="2147483946" r:id="rId16"/>
    <p:sldLayoutId id="2147483947" r:id="rId1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4.xml"/><Relationship Id="rId1" Type="http://schemas.openxmlformats.org/officeDocument/2006/relationships/tags" Target="../tags/tag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4.xml"/><Relationship Id="rId1" Type="http://schemas.openxmlformats.org/officeDocument/2006/relationships/tags" Target="../tags/tag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-189768" y="2133600"/>
            <a:ext cx="6808110" cy="2135070"/>
          </a:xfrm>
        </p:spPr>
        <p:txBody>
          <a:bodyPr>
            <a:noAutofit/>
          </a:bodyPr>
          <a:lstStyle/>
          <a:p>
            <a:r>
              <a:rPr lang="en-US" sz="6000" dirty="0" err="1">
                <a:latin typeface="Calibri" panose="020F0502020204030204" pitchFamily="34" charset="0"/>
                <a:cs typeface="Calibri" panose="020F0502020204030204" pitchFamily="34" charset="0"/>
              </a:rPr>
              <a:t>Dermatoethics</a:t>
            </a:r>
            <a:r>
              <a:rPr lang="en-US" sz="6000" dirty="0">
                <a:latin typeface="Calibri" panose="020F0502020204030204" pitchFamily="34" charset="0"/>
                <a:cs typeface="Calibri" panose="020F0502020204030204" pitchFamily="34" charset="0"/>
              </a:rPr>
              <a:t> Primer</a:t>
            </a:r>
          </a:p>
        </p:txBody>
      </p:sp>
    </p:spTree>
    <p:extLst>
      <p:ext uri="{BB962C8B-B14F-4D97-AF65-F5344CB8AC3E}">
        <p14:creationId xmlns:p14="http://schemas.microsoft.com/office/powerpoint/2010/main" val="3140432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B0807-2E88-9943-83C1-1875EC61A7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Introduc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FE497F-C3E1-A349-AA0A-D41B6EA278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3400" y="2336873"/>
            <a:ext cx="7772400" cy="3599316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What constitutes an “ethical” problem?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Opposed to strictly medical, legal or regulatory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What principles do ethicists draw upon to make arguments about right and wrong courses of action?</a:t>
            </a:r>
          </a:p>
        </p:txBody>
      </p:sp>
    </p:spTree>
    <p:extLst>
      <p:ext uri="{BB962C8B-B14F-4D97-AF65-F5344CB8AC3E}">
        <p14:creationId xmlns:p14="http://schemas.microsoft.com/office/powerpoint/2010/main" val="25338368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What is ethics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" y="2336872"/>
            <a:ext cx="7696200" cy="4368727"/>
          </a:xfrm>
        </p:spPr>
        <p:txBody>
          <a:bodyPr>
            <a:noAutofit/>
          </a:bodyPr>
          <a:lstStyle/>
          <a:p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Understanding human behavior in relation to values</a:t>
            </a:r>
            <a:endParaRPr lang="en-US" sz="3600" baseline="30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/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How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we determine right and wrong</a:t>
            </a: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Deliberation about </a:t>
            </a:r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particular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actions</a:t>
            </a: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Argumentation</a:t>
            </a: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Conflict occurs when there are </a:t>
            </a:r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competing values 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directing an action</a:t>
            </a:r>
          </a:p>
          <a:p>
            <a:pPr lvl="2"/>
            <a:endParaRPr 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/>
            <a:endParaRPr lang="en-US" sz="3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/>
            <a:endParaRPr lang="en-US" sz="3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6899B75-5027-CD46-9960-AE4025D56C91}"/>
              </a:ext>
            </a:extLst>
          </p:cNvPr>
          <p:cNvSpPr txBox="1"/>
          <p:nvPr/>
        </p:nvSpPr>
        <p:spPr>
          <a:xfrm>
            <a:off x="8802963" y="20222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3869387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What is an ethical dilemma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“</a:t>
            </a:r>
            <a:r>
              <a:rPr lang="en-US" sz="3600" i="1" dirty="0">
                <a:latin typeface="Calibri" panose="020F0502020204030204" pitchFamily="34" charset="0"/>
                <a:cs typeface="Calibri" panose="020F0502020204030204" pitchFamily="34" charset="0"/>
              </a:rPr>
              <a:t>Choice</a:t>
            </a:r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 between what seems to be </a:t>
            </a:r>
            <a:r>
              <a:rPr lang="en-US" sz="3600" i="1" dirty="0">
                <a:latin typeface="Calibri" panose="020F0502020204030204" pitchFamily="34" charset="0"/>
                <a:cs typeface="Calibri" panose="020F0502020204030204" pitchFamily="34" charset="0"/>
              </a:rPr>
              <a:t>equally undesirable alternatives</a:t>
            </a:r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… each of which seems to be </a:t>
            </a:r>
            <a:r>
              <a:rPr lang="en-US" sz="3600" i="1" dirty="0">
                <a:latin typeface="Calibri" panose="020F0502020204030204" pitchFamily="34" charset="0"/>
                <a:cs typeface="Calibri" panose="020F0502020204030204" pitchFamily="34" charset="0"/>
              </a:rPr>
              <a:t>justified</a:t>
            </a:r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 by a </a:t>
            </a:r>
            <a:r>
              <a:rPr lang="en-US" sz="3600" i="1" dirty="0">
                <a:latin typeface="Calibri" panose="020F0502020204030204" pitchFamily="34" charset="0"/>
                <a:cs typeface="Calibri" panose="020F0502020204030204" pitchFamily="34" charset="0"/>
              </a:rPr>
              <a:t>moral</a:t>
            </a:r>
            <a:r>
              <a:rPr lang="en-US" sz="3600" dirty="0">
                <a:latin typeface="Calibri" panose="020F0502020204030204" pitchFamily="34" charset="0"/>
                <a:cs typeface="Calibri" panose="020F0502020204030204" pitchFamily="34" charset="0"/>
              </a:rPr>
              <a:t> value”</a:t>
            </a:r>
            <a:endParaRPr lang="en-US" sz="3600" baseline="30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Choice</a:t>
            </a: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No clear </a:t>
            </a:r>
            <a:r>
              <a:rPr lang="en-US" sz="3200" i="1" dirty="0">
                <a:latin typeface="Calibri" panose="020F0502020204030204" pitchFamily="34" charset="0"/>
                <a:cs typeface="Calibri" panose="020F0502020204030204" pitchFamily="34" charset="0"/>
              </a:rPr>
              <a:t>right</a:t>
            </a:r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 answer</a:t>
            </a:r>
          </a:p>
          <a:p>
            <a:pPr lvl="1"/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Justific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B0863B-9AE5-DE4D-A9BC-5511B74435AA}"/>
              </a:ext>
            </a:extLst>
          </p:cNvPr>
          <p:cNvSpPr txBox="1"/>
          <p:nvPr/>
        </p:nvSpPr>
        <p:spPr>
          <a:xfrm>
            <a:off x="8802963" y="20222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1308789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How to analyze an ethics case:</a:t>
            </a:r>
            <a:b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	Principles of Bioeth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3400" y="2336873"/>
            <a:ext cx="3556304" cy="3599316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Autonomy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Promoting self-directed care</a:t>
            </a:r>
          </a:p>
          <a:p>
            <a:pPr marL="0" indent="0">
              <a:lnSpc>
                <a:spcPct val="100000"/>
              </a:lnSpc>
              <a:spcBef>
                <a:spcPts val="600"/>
              </a:spcBef>
              <a:buNone/>
            </a:pPr>
            <a:endParaRPr 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Beneficence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Doing what’s best for the patient’s health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endParaRPr 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67200" y="2336873"/>
            <a:ext cx="3359661" cy="3599316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Non-maleficence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Avoiding harm</a:t>
            </a:r>
          </a:p>
          <a:p>
            <a:pPr marL="457200" lvl="1" indent="0">
              <a:lnSpc>
                <a:spcPct val="100000"/>
              </a:lnSpc>
              <a:spcBef>
                <a:spcPts val="600"/>
              </a:spcBef>
              <a:buNone/>
            </a:pPr>
            <a:endParaRPr 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457200" lvl="1" indent="0">
              <a:lnSpc>
                <a:spcPct val="100000"/>
              </a:lnSpc>
              <a:spcBef>
                <a:spcPts val="600"/>
              </a:spcBef>
              <a:buNone/>
            </a:pPr>
            <a:endParaRPr 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Justice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Being fai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63AB53-9943-D64B-9C3D-5035575B7AE4}"/>
              </a:ext>
            </a:extLst>
          </p:cNvPr>
          <p:cNvSpPr txBox="1"/>
          <p:nvPr/>
        </p:nvSpPr>
        <p:spPr>
          <a:xfrm>
            <a:off x="8802963" y="20222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825952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Other Moral Theory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533400" y="2336872"/>
            <a:ext cx="7543800" cy="4216327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Duty-based</a:t>
            </a:r>
          </a:p>
          <a:p>
            <a:pPr lvl="1"/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What action adheres best to rules and standards?</a:t>
            </a:r>
          </a:p>
          <a:p>
            <a:pPr marL="457200" lvl="1" indent="0">
              <a:buNone/>
            </a:pPr>
            <a:endParaRPr 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Consequence-based</a:t>
            </a:r>
          </a:p>
          <a:p>
            <a:pPr lvl="1"/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What action gives the best outcome for the individual or group?</a:t>
            </a:r>
          </a:p>
          <a:p>
            <a:pPr marL="457200" lvl="1" indent="0">
              <a:buNone/>
            </a:pPr>
            <a:endParaRPr 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Virtue-based</a:t>
            </a:r>
          </a:p>
          <a:p>
            <a:pPr lvl="1"/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What action would an admired person do in this situation?</a:t>
            </a:r>
          </a:p>
        </p:txBody>
      </p:sp>
    </p:spTree>
    <p:extLst>
      <p:ext uri="{BB962C8B-B14F-4D97-AF65-F5344CB8AC3E}">
        <p14:creationId xmlns:p14="http://schemas.microsoft.com/office/powerpoint/2010/main" val="13427217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6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Quadrant Model for Case Analysi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304800" y="2336873"/>
            <a:ext cx="4114800" cy="3599316"/>
          </a:xfrm>
        </p:spPr>
        <p:txBody>
          <a:bodyPr>
            <a:normAutofit/>
          </a:bodyPr>
          <a:lstStyle/>
          <a:p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Medical Indication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What would benefit the patient medically?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What would avoid harm?</a:t>
            </a:r>
          </a:p>
          <a:p>
            <a:pPr lvl="1"/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Quality of Life Consideration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How will patient’s remaining life be affected with and without treatment?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>
          <a:xfrm>
            <a:off x="4419600" y="2336873"/>
            <a:ext cx="4114800" cy="4021931"/>
          </a:xfrm>
        </p:spPr>
        <p:txBody>
          <a:bodyPr>
            <a:normAutofit/>
          </a:bodyPr>
          <a:lstStyle/>
          <a:p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Patient Preference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Decision making capacity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Stated preferences by patient or surrogate</a:t>
            </a:r>
          </a:p>
          <a:p>
            <a:pPr lvl="1"/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Contextual Feature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Legal consideration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ultural/religious factor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Limited resources/fairness</a:t>
            </a:r>
          </a:p>
          <a:p>
            <a:pPr lvl="1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onflict of interest</a:t>
            </a:r>
          </a:p>
          <a:p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1"/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237D6FF-9E52-BD4E-9C5E-D28D61129411}"/>
              </a:ext>
            </a:extLst>
          </p:cNvPr>
          <p:cNvSpPr txBox="1"/>
          <p:nvPr/>
        </p:nvSpPr>
        <p:spPr>
          <a:xfrm>
            <a:off x="8802963" y="20222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9803753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" fill="hold">
                      <p:stCondLst>
                        <p:cond delay="indefinite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500"/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500"/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3" dur="500"/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500"/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500"/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77045-763A-452F-84D1-627D0B04A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Common Topics in Bioethics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588584B-0368-41B0-B8E3-E399F6847B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3400" y="2336873"/>
            <a:ext cx="7848600" cy="3599316"/>
          </a:xfrm>
        </p:spPr>
        <p:txBody>
          <a:bodyPr>
            <a:norm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Informed consent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Privacy and confidentiality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Considerations for minors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Communication and provider-patient relationship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ocial and cultural determinants of healthcare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Conflict of interest</a:t>
            </a:r>
          </a:p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End-of-life decis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908703-9199-6146-B804-39530A80B4B6}"/>
              </a:ext>
            </a:extLst>
          </p:cNvPr>
          <p:cNvSpPr txBox="1"/>
          <p:nvPr/>
        </p:nvSpPr>
        <p:spPr>
          <a:xfrm>
            <a:off x="8802963" y="20222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7192282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8F482-DB91-244F-BB3D-535E34E487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Calibri" panose="020F0502020204030204" pitchFamily="34" charset="0"/>
                <a:cs typeface="Calibri" panose="020F0502020204030204" pitchFamily="34" charset="0"/>
              </a:rPr>
              <a:t>Referenc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F8440-45A1-7541-B83D-B8BB3AEBE567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507826" y="2286000"/>
            <a:ext cx="7620000" cy="39292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95275" indent="-295275">
              <a:buFont typeface="+mj-lt"/>
              <a:buAutoNum type="arabicPeriod"/>
            </a:pP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Home: Emory Center for Ethics: Atlanta GA. (n.d.). http://www.ethics.emory.edu. Accessed 26 September 2020.</a:t>
            </a:r>
          </a:p>
          <a:p>
            <a:pPr marL="295275" indent="-295275">
              <a:buFont typeface="+mj-lt"/>
              <a:buAutoNum type="arabicPeriod"/>
            </a:pP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DuVal G, </a:t>
            </a:r>
            <a:r>
              <a:rPr lang="en-US" sz="2000" i="1" dirty="0">
                <a:latin typeface="Calibri" panose="020F0502020204030204" pitchFamily="34" charset="0"/>
                <a:cs typeface="Calibri" panose="020F0502020204030204" pitchFamily="34" charset="0"/>
              </a:rPr>
              <a:t>et al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. A national survey of U.S. internists’ experiences with ethical dilemmas and ethics consultation.  </a:t>
            </a:r>
            <a:r>
              <a:rPr lang="en-US" sz="2000" i="1" dirty="0">
                <a:latin typeface="Calibri" panose="020F0502020204030204" pitchFamily="34" charset="0"/>
                <a:cs typeface="Calibri" panose="020F0502020204030204" pitchFamily="34" charset="0"/>
              </a:rPr>
              <a:t>J Gen Intern Med 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2004 19(3): 251-8.</a:t>
            </a:r>
          </a:p>
          <a:p>
            <a:pPr marL="295275" indent="-295275">
              <a:buFont typeface="+mj-lt"/>
              <a:buAutoNum type="arabicPeriod"/>
            </a:pP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Beauchamp and Childress. </a:t>
            </a:r>
            <a:r>
              <a:rPr lang="en-US" sz="2000" u="sng" dirty="0">
                <a:latin typeface="Calibri" panose="020F0502020204030204" pitchFamily="34" charset="0"/>
                <a:cs typeface="Calibri" panose="020F0502020204030204" pitchFamily="34" charset="0"/>
              </a:rPr>
              <a:t>Principles of biomedical ethics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. 6th ed. 2009.</a:t>
            </a:r>
          </a:p>
          <a:p>
            <a:pPr marL="295275" indent="-295275">
              <a:buFont typeface="+mj-lt"/>
              <a:buAutoNum type="arabicPeriod"/>
            </a:pPr>
            <a:r>
              <a:rPr lang="en-US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Jonsen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2000" i="1" dirty="0">
                <a:latin typeface="Calibri" panose="020F0502020204030204" pitchFamily="34" charset="0"/>
                <a:cs typeface="Calibri" panose="020F0502020204030204" pitchFamily="34" charset="0"/>
              </a:rPr>
              <a:t>et al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2000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2000" u="sng" dirty="0">
                <a:latin typeface="Calibri" panose="020F0502020204030204" pitchFamily="34" charset="0"/>
                <a:cs typeface="Calibri" panose="020F0502020204030204" pitchFamily="34" charset="0"/>
              </a:rPr>
              <a:t>Clinical Ethics: A practical approach to ethical decisions in clinical medicine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, 2006.</a:t>
            </a:r>
          </a:p>
          <a:p>
            <a:pPr marL="295275" indent="-295275">
              <a:buFont typeface="+mj-lt"/>
              <a:buAutoNum type="arabicPeriod"/>
            </a:pPr>
            <a:r>
              <a:rPr lang="en-US" sz="2000" i="1" dirty="0">
                <a:latin typeface="Calibri" panose="020F0502020204030204" pitchFamily="34" charset="0"/>
                <a:cs typeface="Calibri" panose="020F0502020204030204" pitchFamily="34" charset="0"/>
              </a:rPr>
              <a:t>Improving Competencies in Clinical Ethics Consultation: An Educational Guide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. 2009. Glenview, IL: American Society for Bioethics and Humanities.</a:t>
            </a:r>
          </a:p>
        </p:txBody>
      </p:sp>
    </p:spTree>
    <p:extLst>
      <p:ext uri="{BB962C8B-B14F-4D97-AF65-F5344CB8AC3E}">
        <p14:creationId xmlns:p14="http://schemas.microsoft.com/office/powerpoint/2010/main" val="403072278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7.6|17.1|20.8|16.6|8.7|16.4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.6|0.2|0.1|0.1|0.1|0.1|0.1|0.2|0.4|0.9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9.9|6.1|4.3|4.9"/>
</p:tagLst>
</file>

<file path=ppt/theme/theme1.xml><?xml version="1.0" encoding="utf-8"?>
<a:theme xmlns:a="http://schemas.openxmlformats.org/drawingml/2006/main" name="Berlin">
  <a:themeElements>
    <a:clrScheme name="Berlin">
      <a:dk1>
        <a:sysClr val="windowText" lastClr="000000"/>
      </a:dk1>
      <a:lt1>
        <a:sysClr val="window" lastClr="FFFFFF"/>
      </a:lt1>
      <a:dk2>
        <a:srgbClr val="1F8094"/>
      </a:dk2>
      <a:lt2>
        <a:srgbClr val="E7E6E6"/>
      </a:lt2>
      <a:accent1>
        <a:srgbClr val="39CDE7"/>
      </a:accent1>
      <a:accent2>
        <a:srgbClr val="60DE72"/>
      </a:accent2>
      <a:accent3>
        <a:srgbClr val="DDCC64"/>
      </a:accent3>
      <a:accent4>
        <a:srgbClr val="F49D50"/>
      </a:accent4>
      <a:accent5>
        <a:srgbClr val="E44951"/>
      </a:accent5>
      <a:accent6>
        <a:srgbClr val="D666F9"/>
      </a:accent6>
      <a:hlink>
        <a:srgbClr val="4BF7ED"/>
      </a:hlink>
      <a:folHlink>
        <a:srgbClr val="95E9F4"/>
      </a:folHlink>
    </a:clrScheme>
    <a:fontScheme name="Berlin">
      <a:majorFont>
        <a:latin typeface="Trebuchet MS" panose="020B0603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rebuchet MS" panose="020B0603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erlin">
      <a:fillStyleLst>
        <a:solidFill>
          <a:schemeClr val="phClr"/>
        </a:solidFill>
        <a:gradFill rotWithShape="1">
          <a:gsLst>
            <a:gs pos="0">
              <a:schemeClr val="phClr">
                <a:tint val="60000"/>
                <a:satMod val="100000"/>
                <a:lumMod val="110000"/>
              </a:schemeClr>
            </a:gs>
            <a:gs pos="100000">
              <a:schemeClr val="phClr">
                <a:tint val="70000"/>
                <a:satMod val="100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6000"/>
                <a:shade val="100000"/>
                <a:hueMod val="92000"/>
                <a:satMod val="200000"/>
                <a:lumMod val="128000"/>
              </a:schemeClr>
            </a:gs>
            <a:gs pos="50000">
              <a:schemeClr val="phClr">
                <a:shade val="100000"/>
                <a:hueMod val="100000"/>
                <a:satMod val="110000"/>
                <a:lumMod val="130000"/>
              </a:schemeClr>
            </a:gs>
            <a:gs pos="100000">
              <a:schemeClr val="phClr">
                <a:shade val="78000"/>
                <a:hueMod val="118000"/>
                <a:satMod val="120000"/>
                <a:lumMod val="69000"/>
              </a:schemeClr>
            </a:gs>
          </a:gsLst>
          <a:lin ang="252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erlin" id="{7B5DBA9E-B069-418E-9360-A61BDD0615A4}" vid="{C7DC10E3-4FF5-456B-A359-A0F378C1E5FB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679F25CD40CEB4FA80B20B7D41BD18D" ma:contentTypeVersion="4" ma:contentTypeDescription="Create a new document." ma:contentTypeScope="" ma:versionID="dfdd101c18bba0da3a7335ca4ecf417b">
  <xsd:schema xmlns:xsd="http://www.w3.org/2001/XMLSchema" xmlns:xs="http://www.w3.org/2001/XMLSchema" xmlns:p="http://schemas.microsoft.com/office/2006/metadata/properties" xmlns:ns3="4f2bc80f-78a1-4814-af8d-9fd07fb3c43f" targetNamespace="http://schemas.microsoft.com/office/2006/metadata/properties" ma:root="true" ma:fieldsID="ba8324e7702d55ca20aa8132781d0ecc" ns3:_="">
    <xsd:import namespace="4f2bc80f-78a1-4814-af8d-9fd07fb3c43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f2bc80f-78a1-4814-af8d-9fd07fb3c43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5898DB1-15BC-42E8-B740-609BF5C01AC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A019535-EFEA-4A5B-BFF0-245C96947ED1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http://purl.org/dc/terms/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4f2bc80f-78a1-4814-af8d-9fd07fb3c43f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41B99B7-2076-4CC9-BE21-57CCC0CAC96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f2bc80f-78a1-4814-af8d-9fd07fb3c43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1595</TotalTime>
  <Words>680</Words>
  <Application>Microsoft Office PowerPoint</Application>
  <PresentationFormat>On-screen Show (4:3)</PresentationFormat>
  <Paragraphs>100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Trebuchet MS</vt:lpstr>
      <vt:lpstr>Berlin</vt:lpstr>
      <vt:lpstr>Dermatoethics Primer</vt:lpstr>
      <vt:lpstr>Introduction</vt:lpstr>
      <vt:lpstr>What is ethics?</vt:lpstr>
      <vt:lpstr>What is an ethical dilemma?</vt:lpstr>
      <vt:lpstr>How to analyze an ethics case:  Principles of Bioethics</vt:lpstr>
      <vt:lpstr>Other Moral Theory</vt:lpstr>
      <vt:lpstr>Quadrant Model for Case Analysis</vt:lpstr>
      <vt:lpstr>Common Topics in Bioethics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thics in Dermatopathology</dc:title>
  <dc:creator>Nathanael Coombs Jensen</dc:creator>
  <cp:lastModifiedBy>Sarah Cipriano</cp:lastModifiedBy>
  <cp:revision>192</cp:revision>
  <dcterms:created xsi:type="dcterms:W3CDTF">2019-11-22T16:40:36Z</dcterms:created>
  <dcterms:modified xsi:type="dcterms:W3CDTF">2022-11-22T18:32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679F25CD40CEB4FA80B20B7D41BD18D</vt:lpwstr>
  </property>
</Properties>
</file>